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3419475" cy="3870325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DB055C-C81C-49C3-B22F-7D31728D222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171000" y="155160"/>
            <a:ext cx="3078360" cy="644760"/>
          </a:xfrm>
          <a:prstGeom prst="rect">
            <a:avLst/>
          </a:prstGeom>
          <a:noFill/>
          <a:ln w="0">
            <a:noFill/>
          </a:ln>
        </p:spPr>
        <p:txBody>
          <a:bodyPr lIns="41760" rIns="41760" tIns="20880" bIns="20880" anchor="ctr">
            <a:noAutofit/>
          </a:bodyPr>
          <a:p>
            <a:pPr indent="0" algn="ctr">
              <a:buNone/>
              <a:tabLst>
                <a:tab algn="l" pos="0"/>
                <a:tab algn="l" pos="415800"/>
                <a:tab algn="l" pos="831960"/>
                <a:tab algn="l" pos="1247760"/>
                <a:tab algn="l" pos="1663560"/>
                <a:tab algn="l" pos="2079720"/>
                <a:tab algn="l" pos="2495520"/>
                <a:tab algn="l" pos="2911320"/>
                <a:tab algn="l" pos="3327480"/>
                <a:tab algn="l" pos="3743280"/>
                <a:tab algn="l" pos="4159080"/>
                <a:tab algn="l" pos="4575240"/>
                <a:tab algn="l" pos="4991040"/>
                <a:tab algn="l" pos="5407200"/>
                <a:tab algn="l" pos="5823000"/>
                <a:tab algn="l" pos="6238800"/>
                <a:tab algn="l" pos="6654960"/>
                <a:tab algn="l" pos="7070760"/>
                <a:tab algn="l" pos="7486560"/>
                <a:tab algn="l" pos="7902720"/>
                <a:tab algn="l" pos="831852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171000" y="902880"/>
            <a:ext cx="3078360" cy="1218240"/>
          </a:xfrm>
          <a:prstGeom prst="rect">
            <a:avLst/>
          </a:prstGeom>
          <a:noFill/>
          <a:ln w="0">
            <a:noFill/>
          </a:ln>
        </p:spPr>
        <p:txBody>
          <a:bodyPr lIns="41760" rIns="41760" tIns="20880" bIns="2088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15800"/>
                <a:tab algn="l" pos="831960"/>
                <a:tab algn="l" pos="1247760"/>
                <a:tab algn="l" pos="1663560"/>
                <a:tab algn="l" pos="2079720"/>
                <a:tab algn="l" pos="2495520"/>
                <a:tab algn="l" pos="2911320"/>
                <a:tab algn="l" pos="3327480"/>
                <a:tab algn="l" pos="3743280"/>
                <a:tab algn="l" pos="4159080"/>
                <a:tab algn="l" pos="4575240"/>
                <a:tab algn="l" pos="4991040"/>
                <a:tab algn="l" pos="5407200"/>
                <a:tab algn="l" pos="5823000"/>
                <a:tab algn="l" pos="6238800"/>
                <a:tab algn="l" pos="6654960"/>
                <a:tab algn="l" pos="7070760"/>
                <a:tab algn="l" pos="7486560"/>
                <a:tab algn="l" pos="7902720"/>
                <a:tab algn="l" pos="831852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171000" y="2237400"/>
            <a:ext cx="3078360" cy="1218240"/>
          </a:xfrm>
          <a:prstGeom prst="rect">
            <a:avLst/>
          </a:prstGeom>
          <a:noFill/>
          <a:ln w="0">
            <a:noFill/>
          </a:ln>
        </p:spPr>
        <p:txBody>
          <a:bodyPr lIns="41760" rIns="41760" tIns="20880" bIns="2088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15800"/>
                <a:tab algn="l" pos="831960"/>
                <a:tab algn="l" pos="1247760"/>
                <a:tab algn="l" pos="1663560"/>
                <a:tab algn="l" pos="2079720"/>
                <a:tab algn="l" pos="2495520"/>
                <a:tab algn="l" pos="2911320"/>
                <a:tab algn="l" pos="3327480"/>
                <a:tab algn="l" pos="3743280"/>
                <a:tab algn="l" pos="4159080"/>
                <a:tab algn="l" pos="4575240"/>
                <a:tab algn="l" pos="4991040"/>
                <a:tab algn="l" pos="5407200"/>
                <a:tab algn="l" pos="5823000"/>
                <a:tab algn="l" pos="6238800"/>
                <a:tab algn="l" pos="6654960"/>
                <a:tab algn="l" pos="7070760"/>
                <a:tab algn="l" pos="7486560"/>
                <a:tab algn="l" pos="7902720"/>
                <a:tab algn="l" pos="831852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16A6E4-BCDD-4591-B754-D4E397531A4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171000" y="155160"/>
            <a:ext cx="3078360" cy="644760"/>
          </a:xfrm>
          <a:prstGeom prst="rect">
            <a:avLst/>
          </a:prstGeom>
          <a:noFill/>
          <a:ln w="0">
            <a:noFill/>
          </a:ln>
        </p:spPr>
        <p:txBody>
          <a:bodyPr lIns="41760" rIns="41760" tIns="20880" bIns="20880" anchor="ctr">
            <a:noAutofit/>
          </a:bodyPr>
          <a:p>
            <a:pPr indent="0" algn="ctr">
              <a:buNone/>
              <a:tabLst>
                <a:tab algn="l" pos="0"/>
                <a:tab algn="l" pos="415800"/>
                <a:tab algn="l" pos="831960"/>
                <a:tab algn="l" pos="1247760"/>
                <a:tab algn="l" pos="1663560"/>
                <a:tab algn="l" pos="2079720"/>
                <a:tab algn="l" pos="2495520"/>
                <a:tab algn="l" pos="2911320"/>
                <a:tab algn="l" pos="3327480"/>
                <a:tab algn="l" pos="3743280"/>
                <a:tab algn="l" pos="4159080"/>
                <a:tab algn="l" pos="4575240"/>
                <a:tab algn="l" pos="4991040"/>
                <a:tab algn="l" pos="5407200"/>
                <a:tab algn="l" pos="5823000"/>
                <a:tab algn="l" pos="6238800"/>
                <a:tab algn="l" pos="6654960"/>
                <a:tab algn="l" pos="7070760"/>
                <a:tab algn="l" pos="7486560"/>
                <a:tab algn="l" pos="7902720"/>
                <a:tab algn="l" pos="831852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171000" y="902880"/>
            <a:ext cx="1501920" cy="1218240"/>
          </a:xfrm>
          <a:prstGeom prst="rect">
            <a:avLst/>
          </a:prstGeom>
          <a:noFill/>
          <a:ln w="0">
            <a:noFill/>
          </a:ln>
        </p:spPr>
        <p:txBody>
          <a:bodyPr lIns="41760" rIns="41760" tIns="20880" bIns="2088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15800"/>
                <a:tab algn="l" pos="831960"/>
                <a:tab algn="l" pos="1247760"/>
                <a:tab algn="l" pos="1663560"/>
                <a:tab algn="l" pos="2079720"/>
                <a:tab algn="l" pos="2495520"/>
                <a:tab algn="l" pos="2911320"/>
                <a:tab algn="l" pos="3327480"/>
                <a:tab algn="l" pos="3743280"/>
                <a:tab algn="l" pos="4159080"/>
                <a:tab algn="l" pos="4575240"/>
                <a:tab algn="l" pos="4991040"/>
                <a:tab algn="l" pos="5407200"/>
                <a:tab algn="l" pos="5823000"/>
                <a:tab algn="l" pos="6238800"/>
                <a:tab algn="l" pos="6654960"/>
                <a:tab algn="l" pos="7070760"/>
                <a:tab algn="l" pos="7486560"/>
                <a:tab algn="l" pos="7902720"/>
                <a:tab algn="l" pos="831852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1748520" y="902880"/>
            <a:ext cx="1501920" cy="1218240"/>
          </a:xfrm>
          <a:prstGeom prst="rect">
            <a:avLst/>
          </a:prstGeom>
          <a:noFill/>
          <a:ln w="0">
            <a:noFill/>
          </a:ln>
        </p:spPr>
        <p:txBody>
          <a:bodyPr lIns="41760" rIns="41760" tIns="20880" bIns="2088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15800"/>
                <a:tab algn="l" pos="831960"/>
                <a:tab algn="l" pos="1247760"/>
                <a:tab algn="l" pos="1663560"/>
                <a:tab algn="l" pos="2079720"/>
                <a:tab algn="l" pos="2495520"/>
                <a:tab algn="l" pos="2911320"/>
                <a:tab algn="l" pos="3327480"/>
                <a:tab algn="l" pos="3743280"/>
                <a:tab algn="l" pos="4159080"/>
                <a:tab algn="l" pos="4575240"/>
                <a:tab algn="l" pos="4991040"/>
                <a:tab algn="l" pos="5407200"/>
                <a:tab algn="l" pos="5823000"/>
                <a:tab algn="l" pos="6238800"/>
                <a:tab algn="l" pos="6654960"/>
                <a:tab algn="l" pos="7070760"/>
                <a:tab algn="l" pos="7486560"/>
                <a:tab algn="l" pos="7902720"/>
                <a:tab algn="l" pos="831852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171000" y="2237400"/>
            <a:ext cx="1501920" cy="1218240"/>
          </a:xfrm>
          <a:prstGeom prst="rect">
            <a:avLst/>
          </a:prstGeom>
          <a:noFill/>
          <a:ln w="0">
            <a:noFill/>
          </a:ln>
        </p:spPr>
        <p:txBody>
          <a:bodyPr lIns="41760" rIns="41760" tIns="20880" bIns="2088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15800"/>
                <a:tab algn="l" pos="831960"/>
                <a:tab algn="l" pos="1247760"/>
                <a:tab algn="l" pos="1663560"/>
                <a:tab algn="l" pos="2079720"/>
                <a:tab algn="l" pos="2495520"/>
                <a:tab algn="l" pos="2911320"/>
                <a:tab algn="l" pos="3327480"/>
                <a:tab algn="l" pos="3743280"/>
                <a:tab algn="l" pos="4159080"/>
                <a:tab algn="l" pos="4575240"/>
                <a:tab algn="l" pos="4991040"/>
                <a:tab algn="l" pos="5407200"/>
                <a:tab algn="l" pos="5823000"/>
                <a:tab algn="l" pos="6238800"/>
                <a:tab algn="l" pos="6654960"/>
                <a:tab algn="l" pos="7070760"/>
                <a:tab algn="l" pos="7486560"/>
                <a:tab algn="l" pos="7902720"/>
                <a:tab algn="l" pos="831852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1748520" y="2237400"/>
            <a:ext cx="1501920" cy="1218240"/>
          </a:xfrm>
          <a:prstGeom prst="rect">
            <a:avLst/>
          </a:prstGeom>
          <a:noFill/>
          <a:ln w="0">
            <a:noFill/>
          </a:ln>
        </p:spPr>
        <p:txBody>
          <a:bodyPr lIns="41760" rIns="41760" tIns="20880" bIns="2088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15800"/>
                <a:tab algn="l" pos="831960"/>
                <a:tab algn="l" pos="1247760"/>
                <a:tab algn="l" pos="1663560"/>
                <a:tab algn="l" pos="2079720"/>
                <a:tab algn="l" pos="2495520"/>
                <a:tab algn="l" pos="2911320"/>
                <a:tab algn="l" pos="3327480"/>
                <a:tab algn="l" pos="3743280"/>
                <a:tab algn="l" pos="4159080"/>
                <a:tab algn="l" pos="4575240"/>
                <a:tab algn="l" pos="4991040"/>
                <a:tab algn="l" pos="5407200"/>
                <a:tab algn="l" pos="5823000"/>
                <a:tab algn="l" pos="6238800"/>
                <a:tab algn="l" pos="6654960"/>
                <a:tab algn="l" pos="7070760"/>
                <a:tab algn="l" pos="7486560"/>
                <a:tab algn="l" pos="7902720"/>
                <a:tab algn="l" pos="831852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75C8CF-E6D4-49CC-AD77-FCB6A1DA8AC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171000" y="155160"/>
            <a:ext cx="3078360" cy="644760"/>
          </a:xfrm>
          <a:prstGeom prst="rect">
            <a:avLst/>
          </a:prstGeom>
          <a:noFill/>
          <a:ln w="0">
            <a:noFill/>
          </a:ln>
        </p:spPr>
        <p:txBody>
          <a:bodyPr lIns="41760" rIns="41760" tIns="20880" bIns="20880" anchor="ctr">
            <a:noAutofit/>
          </a:bodyPr>
          <a:p>
            <a:pPr indent="0" algn="ctr">
              <a:buNone/>
              <a:tabLst>
                <a:tab algn="l" pos="0"/>
                <a:tab algn="l" pos="415800"/>
                <a:tab algn="l" pos="831960"/>
                <a:tab algn="l" pos="1247760"/>
                <a:tab algn="l" pos="1663560"/>
                <a:tab algn="l" pos="2079720"/>
                <a:tab algn="l" pos="2495520"/>
                <a:tab algn="l" pos="2911320"/>
                <a:tab algn="l" pos="3327480"/>
                <a:tab algn="l" pos="3743280"/>
                <a:tab algn="l" pos="4159080"/>
                <a:tab algn="l" pos="4575240"/>
                <a:tab algn="l" pos="4991040"/>
                <a:tab algn="l" pos="5407200"/>
                <a:tab algn="l" pos="5823000"/>
                <a:tab algn="l" pos="6238800"/>
                <a:tab algn="l" pos="6654960"/>
                <a:tab algn="l" pos="7070760"/>
                <a:tab algn="l" pos="7486560"/>
                <a:tab algn="l" pos="7902720"/>
                <a:tab algn="l" pos="831852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171000" y="902880"/>
            <a:ext cx="991080" cy="1218240"/>
          </a:xfrm>
          <a:prstGeom prst="rect">
            <a:avLst/>
          </a:prstGeom>
          <a:noFill/>
          <a:ln w="0">
            <a:noFill/>
          </a:ln>
        </p:spPr>
        <p:txBody>
          <a:bodyPr lIns="41760" rIns="41760" tIns="20880" bIns="2088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15800"/>
                <a:tab algn="l" pos="831960"/>
                <a:tab algn="l" pos="1247760"/>
                <a:tab algn="l" pos="1663560"/>
                <a:tab algn="l" pos="2079720"/>
                <a:tab algn="l" pos="2495520"/>
                <a:tab algn="l" pos="2911320"/>
                <a:tab algn="l" pos="3327480"/>
                <a:tab algn="l" pos="3743280"/>
                <a:tab algn="l" pos="4159080"/>
                <a:tab algn="l" pos="4575240"/>
                <a:tab algn="l" pos="4991040"/>
                <a:tab algn="l" pos="5407200"/>
                <a:tab algn="l" pos="5823000"/>
                <a:tab algn="l" pos="6238800"/>
                <a:tab algn="l" pos="6654960"/>
                <a:tab algn="l" pos="7070760"/>
                <a:tab algn="l" pos="7486560"/>
                <a:tab algn="l" pos="7902720"/>
                <a:tab algn="l" pos="831852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1212120" y="902880"/>
            <a:ext cx="991080" cy="1218240"/>
          </a:xfrm>
          <a:prstGeom prst="rect">
            <a:avLst/>
          </a:prstGeom>
          <a:noFill/>
          <a:ln w="0">
            <a:noFill/>
          </a:ln>
        </p:spPr>
        <p:txBody>
          <a:bodyPr lIns="41760" rIns="41760" tIns="20880" bIns="2088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15800"/>
                <a:tab algn="l" pos="831960"/>
                <a:tab algn="l" pos="1247760"/>
                <a:tab algn="l" pos="1663560"/>
                <a:tab algn="l" pos="2079720"/>
                <a:tab algn="l" pos="2495520"/>
                <a:tab algn="l" pos="2911320"/>
                <a:tab algn="l" pos="3327480"/>
                <a:tab algn="l" pos="3743280"/>
                <a:tab algn="l" pos="4159080"/>
                <a:tab algn="l" pos="4575240"/>
                <a:tab algn="l" pos="4991040"/>
                <a:tab algn="l" pos="5407200"/>
                <a:tab algn="l" pos="5823000"/>
                <a:tab algn="l" pos="6238800"/>
                <a:tab algn="l" pos="6654960"/>
                <a:tab algn="l" pos="7070760"/>
                <a:tab algn="l" pos="7486560"/>
                <a:tab algn="l" pos="7902720"/>
                <a:tab algn="l" pos="831852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2252880" y="902880"/>
            <a:ext cx="991080" cy="1218240"/>
          </a:xfrm>
          <a:prstGeom prst="rect">
            <a:avLst/>
          </a:prstGeom>
          <a:noFill/>
          <a:ln w="0">
            <a:noFill/>
          </a:ln>
        </p:spPr>
        <p:txBody>
          <a:bodyPr lIns="41760" rIns="41760" tIns="20880" bIns="2088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15800"/>
                <a:tab algn="l" pos="831960"/>
                <a:tab algn="l" pos="1247760"/>
                <a:tab algn="l" pos="1663560"/>
                <a:tab algn="l" pos="2079720"/>
                <a:tab algn="l" pos="2495520"/>
                <a:tab algn="l" pos="2911320"/>
                <a:tab algn="l" pos="3327480"/>
                <a:tab algn="l" pos="3743280"/>
                <a:tab algn="l" pos="4159080"/>
                <a:tab algn="l" pos="4575240"/>
                <a:tab algn="l" pos="4991040"/>
                <a:tab algn="l" pos="5407200"/>
                <a:tab algn="l" pos="5823000"/>
                <a:tab algn="l" pos="6238800"/>
                <a:tab algn="l" pos="6654960"/>
                <a:tab algn="l" pos="7070760"/>
                <a:tab algn="l" pos="7486560"/>
                <a:tab algn="l" pos="7902720"/>
                <a:tab algn="l" pos="831852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171000" y="2237400"/>
            <a:ext cx="991080" cy="1218240"/>
          </a:xfrm>
          <a:prstGeom prst="rect">
            <a:avLst/>
          </a:prstGeom>
          <a:noFill/>
          <a:ln w="0">
            <a:noFill/>
          </a:ln>
        </p:spPr>
        <p:txBody>
          <a:bodyPr lIns="41760" rIns="41760" tIns="20880" bIns="2088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15800"/>
                <a:tab algn="l" pos="831960"/>
                <a:tab algn="l" pos="1247760"/>
                <a:tab algn="l" pos="1663560"/>
                <a:tab algn="l" pos="2079720"/>
                <a:tab algn="l" pos="2495520"/>
                <a:tab algn="l" pos="2911320"/>
                <a:tab algn="l" pos="3327480"/>
                <a:tab algn="l" pos="3743280"/>
                <a:tab algn="l" pos="4159080"/>
                <a:tab algn="l" pos="4575240"/>
                <a:tab algn="l" pos="4991040"/>
                <a:tab algn="l" pos="5407200"/>
                <a:tab algn="l" pos="5823000"/>
                <a:tab algn="l" pos="6238800"/>
                <a:tab algn="l" pos="6654960"/>
                <a:tab algn="l" pos="7070760"/>
                <a:tab algn="l" pos="7486560"/>
                <a:tab algn="l" pos="7902720"/>
                <a:tab algn="l" pos="831852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1212120" y="2237400"/>
            <a:ext cx="991080" cy="1218240"/>
          </a:xfrm>
          <a:prstGeom prst="rect">
            <a:avLst/>
          </a:prstGeom>
          <a:noFill/>
          <a:ln w="0">
            <a:noFill/>
          </a:ln>
        </p:spPr>
        <p:txBody>
          <a:bodyPr lIns="41760" rIns="41760" tIns="20880" bIns="2088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15800"/>
                <a:tab algn="l" pos="831960"/>
                <a:tab algn="l" pos="1247760"/>
                <a:tab algn="l" pos="1663560"/>
                <a:tab algn="l" pos="2079720"/>
                <a:tab algn="l" pos="2495520"/>
                <a:tab algn="l" pos="2911320"/>
                <a:tab algn="l" pos="3327480"/>
                <a:tab algn="l" pos="3743280"/>
                <a:tab algn="l" pos="4159080"/>
                <a:tab algn="l" pos="4575240"/>
                <a:tab algn="l" pos="4991040"/>
                <a:tab algn="l" pos="5407200"/>
                <a:tab algn="l" pos="5823000"/>
                <a:tab algn="l" pos="6238800"/>
                <a:tab algn="l" pos="6654960"/>
                <a:tab algn="l" pos="7070760"/>
                <a:tab algn="l" pos="7486560"/>
                <a:tab algn="l" pos="7902720"/>
                <a:tab algn="l" pos="831852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2252880" y="2237400"/>
            <a:ext cx="991080" cy="1218240"/>
          </a:xfrm>
          <a:prstGeom prst="rect">
            <a:avLst/>
          </a:prstGeom>
          <a:noFill/>
          <a:ln w="0">
            <a:noFill/>
          </a:ln>
        </p:spPr>
        <p:txBody>
          <a:bodyPr lIns="41760" rIns="41760" tIns="20880" bIns="2088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15800"/>
                <a:tab algn="l" pos="831960"/>
                <a:tab algn="l" pos="1247760"/>
                <a:tab algn="l" pos="1663560"/>
                <a:tab algn="l" pos="2079720"/>
                <a:tab algn="l" pos="2495520"/>
                <a:tab algn="l" pos="2911320"/>
                <a:tab algn="l" pos="3327480"/>
                <a:tab algn="l" pos="3743280"/>
                <a:tab algn="l" pos="4159080"/>
                <a:tab algn="l" pos="4575240"/>
                <a:tab algn="l" pos="4991040"/>
                <a:tab algn="l" pos="5407200"/>
                <a:tab algn="l" pos="5823000"/>
                <a:tab algn="l" pos="6238800"/>
                <a:tab algn="l" pos="6654960"/>
                <a:tab algn="l" pos="7070760"/>
                <a:tab algn="l" pos="7486560"/>
                <a:tab algn="l" pos="7902720"/>
                <a:tab algn="l" pos="831852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118F70-15EF-4DD6-A581-BD44B48093D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171000" y="155160"/>
            <a:ext cx="3078360" cy="644760"/>
          </a:xfrm>
          <a:prstGeom prst="rect">
            <a:avLst/>
          </a:prstGeom>
          <a:noFill/>
          <a:ln w="0">
            <a:noFill/>
          </a:ln>
        </p:spPr>
        <p:txBody>
          <a:bodyPr lIns="41760" rIns="41760" tIns="20880" bIns="20880" anchor="ctr">
            <a:noAutofit/>
          </a:bodyPr>
          <a:p>
            <a:pPr indent="0" algn="ctr">
              <a:buNone/>
              <a:tabLst>
                <a:tab algn="l" pos="0"/>
                <a:tab algn="l" pos="415800"/>
                <a:tab algn="l" pos="831960"/>
                <a:tab algn="l" pos="1247760"/>
                <a:tab algn="l" pos="1663560"/>
                <a:tab algn="l" pos="2079720"/>
                <a:tab algn="l" pos="2495520"/>
                <a:tab algn="l" pos="2911320"/>
                <a:tab algn="l" pos="3327480"/>
                <a:tab algn="l" pos="3743280"/>
                <a:tab algn="l" pos="4159080"/>
                <a:tab algn="l" pos="4575240"/>
                <a:tab algn="l" pos="4991040"/>
                <a:tab algn="l" pos="5407200"/>
                <a:tab algn="l" pos="5823000"/>
                <a:tab algn="l" pos="6238800"/>
                <a:tab algn="l" pos="6654960"/>
                <a:tab algn="l" pos="7070760"/>
                <a:tab algn="l" pos="7486560"/>
                <a:tab algn="l" pos="7902720"/>
                <a:tab algn="l" pos="831852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171000" y="902880"/>
            <a:ext cx="3078360" cy="2554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374"/>
              </a:spcBef>
              <a:buNone/>
              <a:tabLst>
                <a:tab algn="l" pos="0"/>
                <a:tab algn="l" pos="415800"/>
                <a:tab algn="l" pos="831960"/>
                <a:tab algn="l" pos="1247760"/>
                <a:tab algn="l" pos="1663560"/>
                <a:tab algn="l" pos="2079720"/>
                <a:tab algn="l" pos="2495520"/>
                <a:tab algn="l" pos="2911320"/>
                <a:tab algn="l" pos="3327480"/>
                <a:tab algn="l" pos="3743280"/>
                <a:tab algn="l" pos="4159080"/>
                <a:tab algn="l" pos="4575240"/>
                <a:tab algn="l" pos="4991040"/>
                <a:tab algn="l" pos="5407200"/>
                <a:tab algn="l" pos="5823000"/>
                <a:tab algn="l" pos="6238800"/>
                <a:tab algn="l" pos="6654960"/>
                <a:tab algn="l" pos="7070760"/>
                <a:tab algn="l" pos="7486560"/>
                <a:tab algn="l" pos="7902720"/>
                <a:tab algn="l" pos="831852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607003-4FB7-4E73-9A17-D05DB6F1398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171000" y="155160"/>
            <a:ext cx="3078360" cy="644760"/>
          </a:xfrm>
          <a:prstGeom prst="rect">
            <a:avLst/>
          </a:prstGeom>
          <a:noFill/>
          <a:ln w="0">
            <a:noFill/>
          </a:ln>
        </p:spPr>
        <p:txBody>
          <a:bodyPr lIns="41760" rIns="41760" tIns="20880" bIns="20880" anchor="ctr">
            <a:noAutofit/>
          </a:bodyPr>
          <a:p>
            <a:pPr indent="0" algn="ctr">
              <a:buNone/>
              <a:tabLst>
                <a:tab algn="l" pos="0"/>
                <a:tab algn="l" pos="415800"/>
                <a:tab algn="l" pos="831960"/>
                <a:tab algn="l" pos="1247760"/>
                <a:tab algn="l" pos="1663560"/>
                <a:tab algn="l" pos="2079720"/>
                <a:tab algn="l" pos="2495520"/>
                <a:tab algn="l" pos="2911320"/>
                <a:tab algn="l" pos="3327480"/>
                <a:tab algn="l" pos="3743280"/>
                <a:tab algn="l" pos="4159080"/>
                <a:tab algn="l" pos="4575240"/>
                <a:tab algn="l" pos="4991040"/>
                <a:tab algn="l" pos="5407200"/>
                <a:tab algn="l" pos="5823000"/>
                <a:tab algn="l" pos="6238800"/>
                <a:tab algn="l" pos="6654960"/>
                <a:tab algn="l" pos="7070760"/>
                <a:tab algn="l" pos="7486560"/>
                <a:tab algn="l" pos="7902720"/>
                <a:tab algn="l" pos="831852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171000" y="902880"/>
            <a:ext cx="3078360" cy="2554200"/>
          </a:xfrm>
          <a:prstGeom prst="rect">
            <a:avLst/>
          </a:prstGeom>
          <a:noFill/>
          <a:ln w="0">
            <a:noFill/>
          </a:ln>
        </p:spPr>
        <p:txBody>
          <a:bodyPr lIns="41760" rIns="41760" tIns="20880" bIns="2088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15800"/>
                <a:tab algn="l" pos="831960"/>
                <a:tab algn="l" pos="1247760"/>
                <a:tab algn="l" pos="1663560"/>
                <a:tab algn="l" pos="2079720"/>
                <a:tab algn="l" pos="2495520"/>
                <a:tab algn="l" pos="2911320"/>
                <a:tab algn="l" pos="3327480"/>
                <a:tab algn="l" pos="3743280"/>
                <a:tab algn="l" pos="4159080"/>
                <a:tab algn="l" pos="4575240"/>
                <a:tab algn="l" pos="4991040"/>
                <a:tab algn="l" pos="5407200"/>
                <a:tab algn="l" pos="5823000"/>
                <a:tab algn="l" pos="6238800"/>
                <a:tab algn="l" pos="6654960"/>
                <a:tab algn="l" pos="7070760"/>
                <a:tab algn="l" pos="7486560"/>
                <a:tab algn="l" pos="7902720"/>
                <a:tab algn="l" pos="831852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4C8696-2C9A-40BC-B996-27440FAC928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171000" y="155160"/>
            <a:ext cx="3078360" cy="644760"/>
          </a:xfrm>
          <a:prstGeom prst="rect">
            <a:avLst/>
          </a:prstGeom>
          <a:noFill/>
          <a:ln w="0">
            <a:noFill/>
          </a:ln>
        </p:spPr>
        <p:txBody>
          <a:bodyPr lIns="41760" rIns="41760" tIns="20880" bIns="20880" anchor="ctr">
            <a:noAutofit/>
          </a:bodyPr>
          <a:p>
            <a:pPr indent="0" algn="ctr">
              <a:buNone/>
              <a:tabLst>
                <a:tab algn="l" pos="0"/>
                <a:tab algn="l" pos="415800"/>
                <a:tab algn="l" pos="831960"/>
                <a:tab algn="l" pos="1247760"/>
                <a:tab algn="l" pos="1663560"/>
                <a:tab algn="l" pos="2079720"/>
                <a:tab algn="l" pos="2495520"/>
                <a:tab algn="l" pos="2911320"/>
                <a:tab algn="l" pos="3327480"/>
                <a:tab algn="l" pos="3743280"/>
                <a:tab algn="l" pos="4159080"/>
                <a:tab algn="l" pos="4575240"/>
                <a:tab algn="l" pos="4991040"/>
                <a:tab algn="l" pos="5407200"/>
                <a:tab algn="l" pos="5823000"/>
                <a:tab algn="l" pos="6238800"/>
                <a:tab algn="l" pos="6654960"/>
                <a:tab algn="l" pos="7070760"/>
                <a:tab algn="l" pos="7486560"/>
                <a:tab algn="l" pos="7902720"/>
                <a:tab algn="l" pos="831852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171000" y="902880"/>
            <a:ext cx="1501920" cy="2554200"/>
          </a:xfrm>
          <a:prstGeom prst="rect">
            <a:avLst/>
          </a:prstGeom>
          <a:noFill/>
          <a:ln w="0">
            <a:noFill/>
          </a:ln>
        </p:spPr>
        <p:txBody>
          <a:bodyPr lIns="41760" rIns="41760" tIns="20880" bIns="2088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15800"/>
                <a:tab algn="l" pos="831960"/>
                <a:tab algn="l" pos="1247760"/>
                <a:tab algn="l" pos="1663560"/>
                <a:tab algn="l" pos="2079720"/>
                <a:tab algn="l" pos="2495520"/>
                <a:tab algn="l" pos="2911320"/>
                <a:tab algn="l" pos="3327480"/>
                <a:tab algn="l" pos="3743280"/>
                <a:tab algn="l" pos="4159080"/>
                <a:tab algn="l" pos="4575240"/>
                <a:tab algn="l" pos="4991040"/>
                <a:tab algn="l" pos="5407200"/>
                <a:tab algn="l" pos="5823000"/>
                <a:tab algn="l" pos="6238800"/>
                <a:tab algn="l" pos="6654960"/>
                <a:tab algn="l" pos="7070760"/>
                <a:tab algn="l" pos="7486560"/>
                <a:tab algn="l" pos="7902720"/>
                <a:tab algn="l" pos="831852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1748520" y="902880"/>
            <a:ext cx="1501920" cy="2554200"/>
          </a:xfrm>
          <a:prstGeom prst="rect">
            <a:avLst/>
          </a:prstGeom>
          <a:noFill/>
          <a:ln w="0">
            <a:noFill/>
          </a:ln>
        </p:spPr>
        <p:txBody>
          <a:bodyPr lIns="41760" rIns="41760" tIns="20880" bIns="2088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15800"/>
                <a:tab algn="l" pos="831960"/>
                <a:tab algn="l" pos="1247760"/>
                <a:tab algn="l" pos="1663560"/>
                <a:tab algn="l" pos="2079720"/>
                <a:tab algn="l" pos="2495520"/>
                <a:tab algn="l" pos="2911320"/>
                <a:tab algn="l" pos="3327480"/>
                <a:tab algn="l" pos="3743280"/>
                <a:tab algn="l" pos="4159080"/>
                <a:tab algn="l" pos="4575240"/>
                <a:tab algn="l" pos="4991040"/>
                <a:tab algn="l" pos="5407200"/>
                <a:tab algn="l" pos="5823000"/>
                <a:tab algn="l" pos="6238800"/>
                <a:tab algn="l" pos="6654960"/>
                <a:tab algn="l" pos="7070760"/>
                <a:tab algn="l" pos="7486560"/>
                <a:tab algn="l" pos="7902720"/>
                <a:tab algn="l" pos="831852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2033EF-0BD1-4375-81A1-B94C2A48C27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171000" y="155160"/>
            <a:ext cx="3078360" cy="644760"/>
          </a:xfrm>
          <a:prstGeom prst="rect">
            <a:avLst/>
          </a:prstGeom>
          <a:noFill/>
          <a:ln w="0">
            <a:noFill/>
          </a:ln>
        </p:spPr>
        <p:txBody>
          <a:bodyPr lIns="41760" rIns="41760" tIns="20880" bIns="20880" anchor="ctr">
            <a:noAutofit/>
          </a:bodyPr>
          <a:p>
            <a:pPr indent="0" algn="ctr">
              <a:buNone/>
              <a:tabLst>
                <a:tab algn="l" pos="0"/>
                <a:tab algn="l" pos="415800"/>
                <a:tab algn="l" pos="831960"/>
                <a:tab algn="l" pos="1247760"/>
                <a:tab algn="l" pos="1663560"/>
                <a:tab algn="l" pos="2079720"/>
                <a:tab algn="l" pos="2495520"/>
                <a:tab algn="l" pos="2911320"/>
                <a:tab algn="l" pos="3327480"/>
                <a:tab algn="l" pos="3743280"/>
                <a:tab algn="l" pos="4159080"/>
                <a:tab algn="l" pos="4575240"/>
                <a:tab algn="l" pos="4991040"/>
                <a:tab algn="l" pos="5407200"/>
                <a:tab algn="l" pos="5823000"/>
                <a:tab algn="l" pos="6238800"/>
                <a:tab algn="l" pos="6654960"/>
                <a:tab algn="l" pos="7070760"/>
                <a:tab algn="l" pos="7486560"/>
                <a:tab algn="l" pos="7902720"/>
                <a:tab algn="l" pos="831852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F94E14-48F6-4F4E-9D11-E4EF85C7C8A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171000" y="155160"/>
            <a:ext cx="3078360" cy="2990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374"/>
              </a:spcBef>
              <a:tabLst>
                <a:tab algn="l" pos="0"/>
                <a:tab algn="l" pos="415800"/>
                <a:tab algn="l" pos="831960"/>
                <a:tab algn="l" pos="1247760"/>
                <a:tab algn="l" pos="1663560"/>
                <a:tab algn="l" pos="2079720"/>
                <a:tab algn="l" pos="2495520"/>
                <a:tab algn="l" pos="2911320"/>
                <a:tab algn="l" pos="3327480"/>
                <a:tab algn="l" pos="3743280"/>
                <a:tab algn="l" pos="4159080"/>
                <a:tab algn="l" pos="4575240"/>
                <a:tab algn="l" pos="4991040"/>
                <a:tab algn="l" pos="5407200"/>
                <a:tab algn="l" pos="5823000"/>
                <a:tab algn="l" pos="6238800"/>
                <a:tab algn="l" pos="6654960"/>
                <a:tab algn="l" pos="7070760"/>
                <a:tab algn="l" pos="7486560"/>
                <a:tab algn="l" pos="7902720"/>
                <a:tab algn="l" pos="831852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D154C1-9DF6-4E95-BA6D-A3A5755BF78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171000" y="155160"/>
            <a:ext cx="3078360" cy="644760"/>
          </a:xfrm>
          <a:prstGeom prst="rect">
            <a:avLst/>
          </a:prstGeom>
          <a:noFill/>
          <a:ln w="0">
            <a:noFill/>
          </a:ln>
        </p:spPr>
        <p:txBody>
          <a:bodyPr lIns="41760" rIns="41760" tIns="20880" bIns="20880" anchor="ctr">
            <a:noAutofit/>
          </a:bodyPr>
          <a:p>
            <a:pPr indent="0" algn="ctr">
              <a:buNone/>
              <a:tabLst>
                <a:tab algn="l" pos="0"/>
                <a:tab algn="l" pos="415800"/>
                <a:tab algn="l" pos="831960"/>
                <a:tab algn="l" pos="1247760"/>
                <a:tab algn="l" pos="1663560"/>
                <a:tab algn="l" pos="2079720"/>
                <a:tab algn="l" pos="2495520"/>
                <a:tab algn="l" pos="2911320"/>
                <a:tab algn="l" pos="3327480"/>
                <a:tab algn="l" pos="3743280"/>
                <a:tab algn="l" pos="4159080"/>
                <a:tab algn="l" pos="4575240"/>
                <a:tab algn="l" pos="4991040"/>
                <a:tab algn="l" pos="5407200"/>
                <a:tab algn="l" pos="5823000"/>
                <a:tab algn="l" pos="6238800"/>
                <a:tab algn="l" pos="6654960"/>
                <a:tab algn="l" pos="7070760"/>
                <a:tab algn="l" pos="7486560"/>
                <a:tab algn="l" pos="7902720"/>
                <a:tab algn="l" pos="831852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171000" y="902880"/>
            <a:ext cx="1501920" cy="1218240"/>
          </a:xfrm>
          <a:prstGeom prst="rect">
            <a:avLst/>
          </a:prstGeom>
          <a:noFill/>
          <a:ln w="0">
            <a:noFill/>
          </a:ln>
        </p:spPr>
        <p:txBody>
          <a:bodyPr lIns="41760" rIns="41760" tIns="20880" bIns="2088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15800"/>
                <a:tab algn="l" pos="831960"/>
                <a:tab algn="l" pos="1247760"/>
                <a:tab algn="l" pos="1663560"/>
                <a:tab algn="l" pos="2079720"/>
                <a:tab algn="l" pos="2495520"/>
                <a:tab algn="l" pos="2911320"/>
                <a:tab algn="l" pos="3327480"/>
                <a:tab algn="l" pos="3743280"/>
                <a:tab algn="l" pos="4159080"/>
                <a:tab algn="l" pos="4575240"/>
                <a:tab algn="l" pos="4991040"/>
                <a:tab algn="l" pos="5407200"/>
                <a:tab algn="l" pos="5823000"/>
                <a:tab algn="l" pos="6238800"/>
                <a:tab algn="l" pos="6654960"/>
                <a:tab algn="l" pos="7070760"/>
                <a:tab algn="l" pos="7486560"/>
                <a:tab algn="l" pos="7902720"/>
                <a:tab algn="l" pos="831852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1748520" y="902880"/>
            <a:ext cx="1501920" cy="2554200"/>
          </a:xfrm>
          <a:prstGeom prst="rect">
            <a:avLst/>
          </a:prstGeom>
          <a:noFill/>
          <a:ln w="0">
            <a:noFill/>
          </a:ln>
        </p:spPr>
        <p:txBody>
          <a:bodyPr lIns="41760" rIns="41760" tIns="20880" bIns="2088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15800"/>
                <a:tab algn="l" pos="831960"/>
                <a:tab algn="l" pos="1247760"/>
                <a:tab algn="l" pos="1663560"/>
                <a:tab algn="l" pos="2079720"/>
                <a:tab algn="l" pos="2495520"/>
                <a:tab algn="l" pos="2911320"/>
                <a:tab algn="l" pos="3327480"/>
                <a:tab algn="l" pos="3743280"/>
                <a:tab algn="l" pos="4159080"/>
                <a:tab algn="l" pos="4575240"/>
                <a:tab algn="l" pos="4991040"/>
                <a:tab algn="l" pos="5407200"/>
                <a:tab algn="l" pos="5823000"/>
                <a:tab algn="l" pos="6238800"/>
                <a:tab algn="l" pos="6654960"/>
                <a:tab algn="l" pos="7070760"/>
                <a:tab algn="l" pos="7486560"/>
                <a:tab algn="l" pos="7902720"/>
                <a:tab algn="l" pos="831852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171000" y="2237400"/>
            <a:ext cx="1501920" cy="1218240"/>
          </a:xfrm>
          <a:prstGeom prst="rect">
            <a:avLst/>
          </a:prstGeom>
          <a:noFill/>
          <a:ln w="0">
            <a:noFill/>
          </a:ln>
        </p:spPr>
        <p:txBody>
          <a:bodyPr lIns="41760" rIns="41760" tIns="20880" bIns="2088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15800"/>
                <a:tab algn="l" pos="831960"/>
                <a:tab algn="l" pos="1247760"/>
                <a:tab algn="l" pos="1663560"/>
                <a:tab algn="l" pos="2079720"/>
                <a:tab algn="l" pos="2495520"/>
                <a:tab algn="l" pos="2911320"/>
                <a:tab algn="l" pos="3327480"/>
                <a:tab algn="l" pos="3743280"/>
                <a:tab algn="l" pos="4159080"/>
                <a:tab algn="l" pos="4575240"/>
                <a:tab algn="l" pos="4991040"/>
                <a:tab algn="l" pos="5407200"/>
                <a:tab algn="l" pos="5823000"/>
                <a:tab algn="l" pos="6238800"/>
                <a:tab algn="l" pos="6654960"/>
                <a:tab algn="l" pos="7070760"/>
                <a:tab algn="l" pos="7486560"/>
                <a:tab algn="l" pos="7902720"/>
                <a:tab algn="l" pos="831852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4F5CB2-2ADA-44C0-B4C8-5D849EA8A09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171000" y="155160"/>
            <a:ext cx="3078360" cy="644760"/>
          </a:xfrm>
          <a:prstGeom prst="rect">
            <a:avLst/>
          </a:prstGeom>
          <a:noFill/>
          <a:ln w="0">
            <a:noFill/>
          </a:ln>
        </p:spPr>
        <p:txBody>
          <a:bodyPr lIns="41760" rIns="41760" tIns="20880" bIns="20880" anchor="ctr">
            <a:noAutofit/>
          </a:bodyPr>
          <a:p>
            <a:pPr indent="0" algn="ctr">
              <a:buNone/>
              <a:tabLst>
                <a:tab algn="l" pos="0"/>
                <a:tab algn="l" pos="415800"/>
                <a:tab algn="l" pos="831960"/>
                <a:tab algn="l" pos="1247760"/>
                <a:tab algn="l" pos="1663560"/>
                <a:tab algn="l" pos="2079720"/>
                <a:tab algn="l" pos="2495520"/>
                <a:tab algn="l" pos="2911320"/>
                <a:tab algn="l" pos="3327480"/>
                <a:tab algn="l" pos="3743280"/>
                <a:tab algn="l" pos="4159080"/>
                <a:tab algn="l" pos="4575240"/>
                <a:tab algn="l" pos="4991040"/>
                <a:tab algn="l" pos="5407200"/>
                <a:tab algn="l" pos="5823000"/>
                <a:tab algn="l" pos="6238800"/>
                <a:tab algn="l" pos="6654960"/>
                <a:tab algn="l" pos="7070760"/>
                <a:tab algn="l" pos="7486560"/>
                <a:tab algn="l" pos="7902720"/>
                <a:tab algn="l" pos="831852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171000" y="902880"/>
            <a:ext cx="1501920" cy="2554200"/>
          </a:xfrm>
          <a:prstGeom prst="rect">
            <a:avLst/>
          </a:prstGeom>
          <a:noFill/>
          <a:ln w="0">
            <a:noFill/>
          </a:ln>
        </p:spPr>
        <p:txBody>
          <a:bodyPr lIns="41760" rIns="41760" tIns="20880" bIns="2088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15800"/>
                <a:tab algn="l" pos="831960"/>
                <a:tab algn="l" pos="1247760"/>
                <a:tab algn="l" pos="1663560"/>
                <a:tab algn="l" pos="2079720"/>
                <a:tab algn="l" pos="2495520"/>
                <a:tab algn="l" pos="2911320"/>
                <a:tab algn="l" pos="3327480"/>
                <a:tab algn="l" pos="3743280"/>
                <a:tab algn="l" pos="4159080"/>
                <a:tab algn="l" pos="4575240"/>
                <a:tab algn="l" pos="4991040"/>
                <a:tab algn="l" pos="5407200"/>
                <a:tab algn="l" pos="5823000"/>
                <a:tab algn="l" pos="6238800"/>
                <a:tab algn="l" pos="6654960"/>
                <a:tab algn="l" pos="7070760"/>
                <a:tab algn="l" pos="7486560"/>
                <a:tab algn="l" pos="7902720"/>
                <a:tab algn="l" pos="831852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1748520" y="902880"/>
            <a:ext cx="1501920" cy="1218240"/>
          </a:xfrm>
          <a:prstGeom prst="rect">
            <a:avLst/>
          </a:prstGeom>
          <a:noFill/>
          <a:ln w="0">
            <a:noFill/>
          </a:ln>
        </p:spPr>
        <p:txBody>
          <a:bodyPr lIns="41760" rIns="41760" tIns="20880" bIns="2088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15800"/>
                <a:tab algn="l" pos="831960"/>
                <a:tab algn="l" pos="1247760"/>
                <a:tab algn="l" pos="1663560"/>
                <a:tab algn="l" pos="2079720"/>
                <a:tab algn="l" pos="2495520"/>
                <a:tab algn="l" pos="2911320"/>
                <a:tab algn="l" pos="3327480"/>
                <a:tab algn="l" pos="3743280"/>
                <a:tab algn="l" pos="4159080"/>
                <a:tab algn="l" pos="4575240"/>
                <a:tab algn="l" pos="4991040"/>
                <a:tab algn="l" pos="5407200"/>
                <a:tab algn="l" pos="5823000"/>
                <a:tab algn="l" pos="6238800"/>
                <a:tab algn="l" pos="6654960"/>
                <a:tab algn="l" pos="7070760"/>
                <a:tab algn="l" pos="7486560"/>
                <a:tab algn="l" pos="7902720"/>
                <a:tab algn="l" pos="831852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1748520" y="2237400"/>
            <a:ext cx="1501920" cy="1218240"/>
          </a:xfrm>
          <a:prstGeom prst="rect">
            <a:avLst/>
          </a:prstGeom>
          <a:noFill/>
          <a:ln w="0">
            <a:noFill/>
          </a:ln>
        </p:spPr>
        <p:txBody>
          <a:bodyPr lIns="41760" rIns="41760" tIns="20880" bIns="2088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15800"/>
                <a:tab algn="l" pos="831960"/>
                <a:tab algn="l" pos="1247760"/>
                <a:tab algn="l" pos="1663560"/>
                <a:tab algn="l" pos="2079720"/>
                <a:tab algn="l" pos="2495520"/>
                <a:tab algn="l" pos="2911320"/>
                <a:tab algn="l" pos="3327480"/>
                <a:tab algn="l" pos="3743280"/>
                <a:tab algn="l" pos="4159080"/>
                <a:tab algn="l" pos="4575240"/>
                <a:tab algn="l" pos="4991040"/>
                <a:tab algn="l" pos="5407200"/>
                <a:tab algn="l" pos="5823000"/>
                <a:tab algn="l" pos="6238800"/>
                <a:tab algn="l" pos="6654960"/>
                <a:tab algn="l" pos="7070760"/>
                <a:tab algn="l" pos="7486560"/>
                <a:tab algn="l" pos="7902720"/>
                <a:tab algn="l" pos="831852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4AA02E-5EA2-4D31-843B-5CC5E472459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171000" y="155160"/>
            <a:ext cx="3078360" cy="644760"/>
          </a:xfrm>
          <a:prstGeom prst="rect">
            <a:avLst/>
          </a:prstGeom>
          <a:noFill/>
          <a:ln w="0">
            <a:noFill/>
          </a:ln>
        </p:spPr>
        <p:txBody>
          <a:bodyPr lIns="41760" rIns="41760" tIns="20880" bIns="20880" anchor="ctr">
            <a:noAutofit/>
          </a:bodyPr>
          <a:p>
            <a:pPr indent="0" algn="ctr">
              <a:buNone/>
              <a:tabLst>
                <a:tab algn="l" pos="0"/>
                <a:tab algn="l" pos="415800"/>
                <a:tab algn="l" pos="831960"/>
                <a:tab algn="l" pos="1247760"/>
                <a:tab algn="l" pos="1663560"/>
                <a:tab algn="l" pos="2079720"/>
                <a:tab algn="l" pos="2495520"/>
                <a:tab algn="l" pos="2911320"/>
                <a:tab algn="l" pos="3327480"/>
                <a:tab algn="l" pos="3743280"/>
                <a:tab algn="l" pos="4159080"/>
                <a:tab algn="l" pos="4575240"/>
                <a:tab algn="l" pos="4991040"/>
                <a:tab algn="l" pos="5407200"/>
                <a:tab algn="l" pos="5823000"/>
                <a:tab algn="l" pos="6238800"/>
                <a:tab algn="l" pos="6654960"/>
                <a:tab algn="l" pos="7070760"/>
                <a:tab algn="l" pos="7486560"/>
                <a:tab algn="l" pos="7902720"/>
                <a:tab algn="l" pos="831852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171000" y="902880"/>
            <a:ext cx="1501920" cy="1218240"/>
          </a:xfrm>
          <a:prstGeom prst="rect">
            <a:avLst/>
          </a:prstGeom>
          <a:noFill/>
          <a:ln w="0">
            <a:noFill/>
          </a:ln>
        </p:spPr>
        <p:txBody>
          <a:bodyPr lIns="41760" rIns="41760" tIns="20880" bIns="2088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15800"/>
                <a:tab algn="l" pos="831960"/>
                <a:tab algn="l" pos="1247760"/>
                <a:tab algn="l" pos="1663560"/>
                <a:tab algn="l" pos="2079720"/>
                <a:tab algn="l" pos="2495520"/>
                <a:tab algn="l" pos="2911320"/>
                <a:tab algn="l" pos="3327480"/>
                <a:tab algn="l" pos="3743280"/>
                <a:tab algn="l" pos="4159080"/>
                <a:tab algn="l" pos="4575240"/>
                <a:tab algn="l" pos="4991040"/>
                <a:tab algn="l" pos="5407200"/>
                <a:tab algn="l" pos="5823000"/>
                <a:tab algn="l" pos="6238800"/>
                <a:tab algn="l" pos="6654960"/>
                <a:tab algn="l" pos="7070760"/>
                <a:tab algn="l" pos="7486560"/>
                <a:tab algn="l" pos="7902720"/>
                <a:tab algn="l" pos="831852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1748520" y="902880"/>
            <a:ext cx="1501920" cy="1218240"/>
          </a:xfrm>
          <a:prstGeom prst="rect">
            <a:avLst/>
          </a:prstGeom>
          <a:noFill/>
          <a:ln w="0">
            <a:noFill/>
          </a:ln>
        </p:spPr>
        <p:txBody>
          <a:bodyPr lIns="41760" rIns="41760" tIns="20880" bIns="2088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15800"/>
                <a:tab algn="l" pos="831960"/>
                <a:tab algn="l" pos="1247760"/>
                <a:tab algn="l" pos="1663560"/>
                <a:tab algn="l" pos="2079720"/>
                <a:tab algn="l" pos="2495520"/>
                <a:tab algn="l" pos="2911320"/>
                <a:tab algn="l" pos="3327480"/>
                <a:tab algn="l" pos="3743280"/>
                <a:tab algn="l" pos="4159080"/>
                <a:tab algn="l" pos="4575240"/>
                <a:tab algn="l" pos="4991040"/>
                <a:tab algn="l" pos="5407200"/>
                <a:tab algn="l" pos="5823000"/>
                <a:tab algn="l" pos="6238800"/>
                <a:tab algn="l" pos="6654960"/>
                <a:tab algn="l" pos="7070760"/>
                <a:tab algn="l" pos="7486560"/>
                <a:tab algn="l" pos="7902720"/>
                <a:tab algn="l" pos="831852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171000" y="2237400"/>
            <a:ext cx="3078360" cy="1218240"/>
          </a:xfrm>
          <a:prstGeom prst="rect">
            <a:avLst/>
          </a:prstGeom>
          <a:noFill/>
          <a:ln w="0">
            <a:noFill/>
          </a:ln>
        </p:spPr>
        <p:txBody>
          <a:bodyPr lIns="41760" rIns="41760" tIns="20880" bIns="2088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15800"/>
                <a:tab algn="l" pos="831960"/>
                <a:tab algn="l" pos="1247760"/>
                <a:tab algn="l" pos="1663560"/>
                <a:tab algn="l" pos="2079720"/>
                <a:tab algn="l" pos="2495520"/>
                <a:tab algn="l" pos="2911320"/>
                <a:tab algn="l" pos="3327480"/>
                <a:tab algn="l" pos="3743280"/>
                <a:tab algn="l" pos="4159080"/>
                <a:tab algn="l" pos="4575240"/>
                <a:tab algn="l" pos="4991040"/>
                <a:tab algn="l" pos="5407200"/>
                <a:tab algn="l" pos="5823000"/>
                <a:tab algn="l" pos="6238800"/>
                <a:tab algn="l" pos="6654960"/>
                <a:tab algn="l" pos="7070760"/>
                <a:tab algn="l" pos="7486560"/>
                <a:tab algn="l" pos="7902720"/>
                <a:tab algn="l" pos="831852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4B9DE5-DECB-408F-8C29-09B1294657F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171000" y="155160"/>
            <a:ext cx="3078360" cy="644760"/>
          </a:xfrm>
          <a:prstGeom prst="rect">
            <a:avLst/>
          </a:prstGeom>
          <a:noFill/>
          <a:ln w="0">
            <a:noFill/>
          </a:ln>
        </p:spPr>
        <p:txBody>
          <a:bodyPr lIns="41760" rIns="41760" tIns="20880" bIns="20880" anchor="ctr">
            <a:noAutofit/>
          </a:bodyPr>
          <a:p>
            <a:pPr indent="0" algn="ctr">
              <a:buNone/>
              <a:tabLst>
                <a:tab algn="l" pos="0"/>
                <a:tab algn="l" pos="415800"/>
                <a:tab algn="l" pos="831960"/>
                <a:tab algn="l" pos="1247760"/>
                <a:tab algn="l" pos="1663560"/>
                <a:tab algn="l" pos="2079720"/>
                <a:tab algn="l" pos="2495520"/>
                <a:tab algn="l" pos="2911320"/>
                <a:tab algn="l" pos="3327480"/>
                <a:tab algn="l" pos="3743280"/>
                <a:tab algn="l" pos="4159080"/>
                <a:tab algn="l" pos="4575240"/>
                <a:tab algn="l" pos="4991040"/>
                <a:tab algn="l" pos="5407200"/>
                <a:tab algn="l" pos="5823000"/>
                <a:tab algn="l" pos="6238800"/>
                <a:tab algn="l" pos="6654960"/>
                <a:tab algn="l" pos="7070760"/>
                <a:tab algn="l" pos="7486560"/>
                <a:tab algn="l" pos="7902720"/>
                <a:tab algn="l" pos="831852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171000" y="902880"/>
            <a:ext cx="3078360" cy="2554200"/>
          </a:xfrm>
          <a:prstGeom prst="rect">
            <a:avLst/>
          </a:prstGeom>
          <a:noFill/>
          <a:ln w="0">
            <a:noFill/>
          </a:ln>
        </p:spPr>
        <p:txBody>
          <a:bodyPr lIns="41760" rIns="41760" tIns="20880" bIns="20880" anchor="t">
            <a:normAutofit/>
          </a:bodyPr>
          <a:p>
            <a:pPr marL="155520" indent="-155520">
              <a:spcBef>
                <a:spcPts val="374"/>
              </a:spcBef>
              <a:buClr>
                <a:srgbClr val="000000"/>
              </a:buClr>
              <a:buFont typeface="Arial"/>
              <a:buChar char="•"/>
              <a:tabLst>
                <a:tab algn="l" pos="415800"/>
                <a:tab algn="l" pos="831960"/>
                <a:tab algn="l" pos="1247760"/>
                <a:tab algn="l" pos="1663560"/>
                <a:tab algn="l" pos="2079720"/>
                <a:tab algn="l" pos="2495520"/>
                <a:tab algn="l" pos="2911320"/>
                <a:tab algn="l" pos="3327480"/>
                <a:tab algn="l" pos="3743280"/>
                <a:tab algn="l" pos="4159080"/>
                <a:tab algn="l" pos="4575240"/>
                <a:tab algn="l" pos="4991040"/>
                <a:tab algn="l" pos="5407200"/>
                <a:tab algn="l" pos="5823000"/>
                <a:tab algn="l" pos="6238800"/>
                <a:tab algn="l" pos="6654960"/>
                <a:tab algn="l" pos="7070760"/>
                <a:tab algn="l" pos="7486560"/>
                <a:tab algn="l" pos="7902720"/>
                <a:tab algn="l" pos="831852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  <a:p>
            <a:pPr lvl="1" marL="338040" indent="-129960">
              <a:spcBef>
                <a:spcPts val="374"/>
              </a:spcBef>
              <a:buClr>
                <a:srgbClr val="000000"/>
              </a:buClr>
              <a:buFont typeface="Arial"/>
              <a:buChar char="–"/>
              <a:tabLst>
                <a:tab algn="l" pos="415800"/>
                <a:tab algn="l" pos="831960"/>
                <a:tab algn="l" pos="1247760"/>
                <a:tab algn="l" pos="1663560"/>
                <a:tab algn="l" pos="2079720"/>
                <a:tab algn="l" pos="2495520"/>
                <a:tab algn="l" pos="2911320"/>
                <a:tab algn="l" pos="3327480"/>
                <a:tab algn="l" pos="3743280"/>
                <a:tab algn="l" pos="4159080"/>
                <a:tab algn="l" pos="4575240"/>
                <a:tab algn="l" pos="4991040"/>
                <a:tab algn="l" pos="5407200"/>
                <a:tab algn="l" pos="5823000"/>
                <a:tab algn="l" pos="6238800"/>
                <a:tab algn="l" pos="6654960"/>
                <a:tab algn="l" pos="7070760"/>
                <a:tab algn="l" pos="7486560"/>
                <a:tab algn="l" pos="7902720"/>
                <a:tab algn="l" pos="831852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  <a:p>
            <a:pPr lvl="2" marL="520560" indent="-104760">
              <a:spcBef>
                <a:spcPts val="374"/>
              </a:spcBef>
              <a:buClr>
                <a:srgbClr val="000000"/>
              </a:buClr>
              <a:buFont typeface="Arial"/>
              <a:buChar char="•"/>
              <a:tabLst>
                <a:tab algn="l" pos="415800"/>
                <a:tab algn="l" pos="831960"/>
                <a:tab algn="l" pos="1247760"/>
                <a:tab algn="l" pos="1663560"/>
                <a:tab algn="l" pos="2079720"/>
                <a:tab algn="l" pos="2495520"/>
                <a:tab algn="l" pos="2911320"/>
                <a:tab algn="l" pos="3327480"/>
                <a:tab algn="l" pos="3743280"/>
                <a:tab algn="l" pos="4159080"/>
                <a:tab algn="l" pos="4575240"/>
                <a:tab algn="l" pos="4991040"/>
                <a:tab algn="l" pos="5407200"/>
                <a:tab algn="l" pos="5823000"/>
                <a:tab algn="l" pos="6238800"/>
                <a:tab algn="l" pos="6654960"/>
                <a:tab algn="l" pos="7070760"/>
                <a:tab algn="l" pos="7486560"/>
                <a:tab algn="l" pos="7902720"/>
                <a:tab algn="l" pos="831852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  <a:p>
            <a:pPr lvl="3" marL="728640" indent="-103320">
              <a:spcBef>
                <a:spcPts val="374"/>
              </a:spcBef>
              <a:buClr>
                <a:srgbClr val="000000"/>
              </a:buClr>
              <a:buFont typeface="Arial"/>
              <a:buChar char="–"/>
              <a:tabLst>
                <a:tab algn="l" pos="415800"/>
                <a:tab algn="l" pos="831960"/>
                <a:tab algn="l" pos="1247760"/>
                <a:tab algn="l" pos="1663560"/>
                <a:tab algn="l" pos="2079720"/>
                <a:tab algn="l" pos="2495520"/>
                <a:tab algn="l" pos="2911320"/>
                <a:tab algn="l" pos="3327480"/>
                <a:tab algn="l" pos="3743280"/>
                <a:tab algn="l" pos="4159080"/>
                <a:tab algn="l" pos="4575240"/>
                <a:tab algn="l" pos="4991040"/>
                <a:tab algn="l" pos="5407200"/>
                <a:tab algn="l" pos="5823000"/>
                <a:tab algn="l" pos="6238800"/>
                <a:tab algn="l" pos="6654960"/>
                <a:tab algn="l" pos="7070760"/>
                <a:tab algn="l" pos="7486560"/>
                <a:tab algn="l" pos="7902720"/>
                <a:tab algn="l" pos="831852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  <a:p>
            <a:pPr lvl="4" marL="936720" indent="-103320">
              <a:spcBef>
                <a:spcPts val="374"/>
              </a:spcBef>
              <a:buClr>
                <a:srgbClr val="000000"/>
              </a:buClr>
              <a:buFont typeface="Arial"/>
              <a:buChar char="»"/>
              <a:tabLst>
                <a:tab algn="l" pos="415800"/>
                <a:tab algn="l" pos="831960"/>
                <a:tab algn="l" pos="1247760"/>
                <a:tab algn="l" pos="1663560"/>
                <a:tab algn="l" pos="2079720"/>
                <a:tab algn="l" pos="2495520"/>
                <a:tab algn="l" pos="2911320"/>
                <a:tab algn="l" pos="3327480"/>
                <a:tab algn="l" pos="3743280"/>
                <a:tab algn="l" pos="4159080"/>
                <a:tab algn="l" pos="4575240"/>
                <a:tab algn="l" pos="4991040"/>
                <a:tab algn="l" pos="5407200"/>
                <a:tab algn="l" pos="5823000"/>
                <a:tab algn="l" pos="6238800"/>
                <a:tab algn="l" pos="6654960"/>
                <a:tab algn="l" pos="7070760"/>
                <a:tab algn="l" pos="7486560"/>
                <a:tab algn="l" pos="7902720"/>
                <a:tab algn="l" pos="831852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  <a:p>
            <a:pPr lvl="5" marL="936720" indent="-103320">
              <a:spcBef>
                <a:spcPts val="374"/>
              </a:spcBef>
              <a:buClr>
                <a:srgbClr val="000000"/>
              </a:buClr>
              <a:buFont typeface="Arial"/>
              <a:buChar char="»"/>
              <a:tabLst>
                <a:tab algn="l" pos="415800"/>
                <a:tab algn="l" pos="831960"/>
                <a:tab algn="l" pos="1247760"/>
                <a:tab algn="l" pos="1663560"/>
                <a:tab algn="l" pos="2079720"/>
                <a:tab algn="l" pos="2495520"/>
                <a:tab algn="l" pos="2911320"/>
                <a:tab algn="l" pos="3327480"/>
                <a:tab algn="l" pos="3743280"/>
                <a:tab algn="l" pos="4159080"/>
                <a:tab algn="l" pos="4575240"/>
                <a:tab algn="l" pos="4991040"/>
                <a:tab algn="l" pos="5407200"/>
                <a:tab algn="l" pos="5823000"/>
                <a:tab algn="l" pos="6238800"/>
                <a:tab algn="l" pos="6654960"/>
                <a:tab algn="l" pos="7070760"/>
                <a:tab algn="l" pos="7486560"/>
                <a:tab algn="l" pos="7902720"/>
                <a:tab algn="l" pos="831852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  <a:p>
            <a:pPr lvl="6" marL="936720" indent="-103320">
              <a:spcBef>
                <a:spcPts val="374"/>
              </a:spcBef>
              <a:buClr>
                <a:srgbClr val="000000"/>
              </a:buClr>
              <a:buFont typeface="Arial"/>
              <a:buChar char="»"/>
              <a:tabLst>
                <a:tab algn="l" pos="415800"/>
                <a:tab algn="l" pos="831960"/>
                <a:tab algn="l" pos="1247760"/>
                <a:tab algn="l" pos="1663560"/>
                <a:tab algn="l" pos="2079720"/>
                <a:tab algn="l" pos="2495520"/>
                <a:tab algn="l" pos="2911320"/>
                <a:tab algn="l" pos="3327480"/>
                <a:tab algn="l" pos="3743280"/>
                <a:tab algn="l" pos="4159080"/>
                <a:tab algn="l" pos="4575240"/>
                <a:tab algn="l" pos="4991040"/>
                <a:tab algn="l" pos="5407200"/>
                <a:tab algn="l" pos="5823000"/>
                <a:tab algn="l" pos="6238800"/>
                <a:tab algn="l" pos="6654960"/>
                <a:tab algn="l" pos="7070760"/>
                <a:tab algn="l" pos="7486560"/>
                <a:tab algn="l" pos="7902720"/>
                <a:tab algn="l" pos="831852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171360" y="3524040"/>
            <a:ext cx="798480" cy="268200"/>
          </a:xfrm>
          <a:prstGeom prst="rect">
            <a:avLst/>
          </a:prstGeom>
          <a:noFill/>
          <a:ln w="0">
            <a:noFill/>
          </a:ln>
        </p:spPr>
        <p:txBody>
          <a:bodyPr lIns="41760" rIns="41760" tIns="20880" bIns="2088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1168200" y="3524040"/>
            <a:ext cx="1083960" cy="268200"/>
          </a:xfrm>
          <a:prstGeom prst="rect">
            <a:avLst/>
          </a:prstGeom>
          <a:noFill/>
          <a:ln w="0">
            <a:noFill/>
          </a:ln>
        </p:spPr>
        <p:txBody>
          <a:bodyPr lIns="41760" rIns="41760" tIns="20880" bIns="2088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2451240" y="3524040"/>
            <a:ext cx="798480" cy="268200"/>
          </a:xfrm>
          <a:prstGeom prst="rect">
            <a:avLst/>
          </a:prstGeom>
          <a:noFill/>
          <a:ln w="0">
            <a:noFill/>
          </a:ln>
        </p:spPr>
        <p:txBody>
          <a:bodyPr lIns="41760" rIns="41760" tIns="20880" bIns="20880" anchor="t">
            <a:noAutofit/>
          </a:bodyPr>
          <a:lstStyle>
            <a:lvl1pPr indent="0" algn="r">
              <a:buNone/>
              <a:tabLst>
                <a:tab algn="l" pos="0"/>
                <a:tab algn="l" pos="415800"/>
                <a:tab algn="l" pos="831960"/>
                <a:tab algn="l" pos="1247760"/>
                <a:tab algn="l" pos="1663560"/>
                <a:tab algn="l" pos="2079720"/>
                <a:tab algn="l" pos="2495520"/>
                <a:tab algn="l" pos="2911320"/>
                <a:tab algn="l" pos="3327480"/>
                <a:tab algn="l" pos="3743280"/>
                <a:tab algn="l" pos="4159080"/>
                <a:tab algn="l" pos="4575240"/>
                <a:tab algn="l" pos="4991040"/>
                <a:tab algn="l" pos="5407200"/>
                <a:tab algn="l" pos="5823000"/>
                <a:tab algn="l" pos="6238800"/>
                <a:tab algn="l" pos="6654960"/>
                <a:tab algn="l" pos="7070760"/>
                <a:tab algn="l" pos="7486560"/>
                <a:tab algn="l" pos="7902720"/>
                <a:tab algn="l" pos="8318520"/>
              </a:tabLst>
              <a:defRPr b="0" lang="en-US" sz="6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415800"/>
                <a:tab algn="l" pos="831960"/>
                <a:tab algn="l" pos="1247760"/>
                <a:tab algn="l" pos="1663560"/>
                <a:tab algn="l" pos="2079720"/>
                <a:tab algn="l" pos="2495520"/>
                <a:tab algn="l" pos="2911320"/>
                <a:tab algn="l" pos="3327480"/>
                <a:tab algn="l" pos="3743280"/>
                <a:tab algn="l" pos="4159080"/>
                <a:tab algn="l" pos="4575240"/>
                <a:tab algn="l" pos="4991040"/>
                <a:tab algn="l" pos="5407200"/>
                <a:tab algn="l" pos="5823000"/>
                <a:tab algn="l" pos="6238800"/>
                <a:tab algn="l" pos="6654960"/>
                <a:tab algn="l" pos="7070760"/>
                <a:tab algn="l" pos="7486560"/>
                <a:tab algn="l" pos="7902720"/>
                <a:tab algn="l" pos="8318520"/>
              </a:tabLst>
            </a:pPr>
            <a:fld id="{03080437-FA25-4137-A8F4-3734BB0F5862}" type="slidenum">
              <a:rPr b="0" lang="en-US" sz="6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746280" y="128520"/>
            <a:ext cx="2581200" cy="2685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746280" y="128520"/>
            <a:ext cx="2581200" cy="26859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870120" y="442800"/>
            <a:ext cx="171360" cy="83844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1298520" y="766800"/>
            <a:ext cx="171360" cy="51444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1727280" y="557280"/>
            <a:ext cx="180720" cy="7239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2165400" y="1281240"/>
            <a:ext cx="171360" cy="97128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2593800" y="1281240"/>
            <a:ext cx="171720" cy="100008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3022560" y="1281240"/>
            <a:ext cx="171360" cy="127620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746280" y="2814480"/>
            <a:ext cx="3780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746280" y="2433600"/>
            <a:ext cx="3780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746280" y="2043000"/>
            <a:ext cx="3780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746280" y="1662120"/>
            <a:ext cx="3780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746280" y="1281240"/>
            <a:ext cx="3780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746280" y="900000"/>
            <a:ext cx="3780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746280" y="509760"/>
            <a:ext cx="3780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746280" y="128520"/>
            <a:ext cx="3780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746280" y="1281240"/>
            <a:ext cx="258120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 flipV="1">
            <a:off x="746280" y="1261800"/>
            <a:ext cx="144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 flipV="1">
            <a:off x="1174680" y="1261800"/>
            <a:ext cx="180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 flipV="1">
            <a:off x="1603440" y="1261800"/>
            <a:ext cx="144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 flipV="1">
            <a:off x="2041560" y="1261800"/>
            <a:ext cx="144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 flipV="1">
            <a:off x="2470320" y="1261800"/>
            <a:ext cx="144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 flipV="1">
            <a:off x="2898720" y="1261800"/>
            <a:ext cx="180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 flipV="1">
            <a:off x="3327480" y="1261800"/>
            <a:ext cx="144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440280" y="2757600"/>
            <a:ext cx="2185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-0.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440280" y="2376360"/>
            <a:ext cx="2185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-0.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440280" y="1986120"/>
            <a:ext cx="2185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-0.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440280" y="1604880"/>
            <a:ext cx="2185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-0.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507240" y="122400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0.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507240" y="84312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0.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507240" y="45252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0.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507240" y="7128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0.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 rot="16200000">
            <a:off x="722160" y="2954880"/>
            <a:ext cx="545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Repl.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 rot="16200000">
            <a:off x="1137960" y="2954880"/>
            <a:ext cx="545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Repl.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 rot="16200000">
            <a:off x="1555560" y="2954880"/>
            <a:ext cx="545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Repl.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 rot="16200000">
            <a:off x="1973160" y="2954880"/>
            <a:ext cx="545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Repl.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 rot="16200000">
            <a:off x="2390760" y="2954880"/>
            <a:ext cx="545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Repl.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 rot="16200000">
            <a:off x="2808000" y="2954880"/>
            <a:ext cx="545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Repl.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777600" y="3346560"/>
            <a:ext cx="12672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AOS-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RB1-expressin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2108520" y="3346560"/>
            <a:ext cx="10980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AOS-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RB1-deficien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824040" y="3346560"/>
            <a:ext cx="11509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2128680" y="3354480"/>
            <a:ext cx="11509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Text Box 82"/>
          <p:cNvSpPr/>
          <p:nvPr/>
        </p:nvSpPr>
        <p:spPr>
          <a:xfrm rot="16200000">
            <a:off x="-1075320" y="1345320"/>
            <a:ext cx="2658960" cy="30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og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Arial"/>
              </a:rPr>
              <a:t>10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(CCND1/CDKN2A) expressi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68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2-19T01:37:15Z</dcterms:created>
  <dc:creator>Merck</dc:creator>
  <dc:description/>
  <dc:language>en-US</dc:language>
  <cp:lastModifiedBy>X40312</cp:lastModifiedBy>
  <dcterms:modified xsi:type="dcterms:W3CDTF">2011-02-23T18:56:59Z</dcterms:modified>
  <cp:revision>84</cp:revision>
  <dc:subject/>
  <dc:title>スライド 1</dc:title>
</cp:coreProperties>
</file>